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57" r:id="rId4"/>
    <p:sldId id="258" r:id="rId5"/>
    <p:sldId id="259" r:id="rId6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9" d="100"/>
          <a:sy n="89" d="100"/>
        </p:scale>
        <p:origin x="418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258C-40E7-44D5-83D9-DC4EB74C4057}" type="datetimeFigureOut">
              <a:rPr lang="sv-SE" smtClean="0"/>
              <a:t>2017-09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0F0D-51FB-4F17-B731-F722AAE06AF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51626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258C-40E7-44D5-83D9-DC4EB74C4057}" type="datetimeFigureOut">
              <a:rPr lang="sv-SE" smtClean="0"/>
              <a:t>2017-09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0F0D-51FB-4F17-B731-F722AAE06AF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454219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258C-40E7-44D5-83D9-DC4EB74C4057}" type="datetimeFigureOut">
              <a:rPr lang="sv-SE" smtClean="0"/>
              <a:t>2017-09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0F0D-51FB-4F17-B731-F722AAE06AF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15774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258C-40E7-44D5-83D9-DC4EB74C4057}" type="datetimeFigureOut">
              <a:rPr lang="sv-SE" smtClean="0"/>
              <a:t>2017-09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0F0D-51FB-4F17-B731-F722AAE06AF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14214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258C-40E7-44D5-83D9-DC4EB74C4057}" type="datetimeFigureOut">
              <a:rPr lang="sv-SE" smtClean="0"/>
              <a:t>2017-09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0F0D-51FB-4F17-B731-F722AAE06AF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36208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258C-40E7-44D5-83D9-DC4EB74C4057}" type="datetimeFigureOut">
              <a:rPr lang="sv-SE" smtClean="0"/>
              <a:t>2017-09-13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0F0D-51FB-4F17-B731-F722AAE06AF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11760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258C-40E7-44D5-83D9-DC4EB74C4057}" type="datetimeFigureOut">
              <a:rPr lang="sv-SE" smtClean="0"/>
              <a:t>2017-09-13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0F0D-51FB-4F17-B731-F722AAE06AF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223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258C-40E7-44D5-83D9-DC4EB74C4057}" type="datetimeFigureOut">
              <a:rPr lang="sv-SE" smtClean="0"/>
              <a:t>2017-09-13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0F0D-51FB-4F17-B731-F722AAE06AF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86140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258C-40E7-44D5-83D9-DC4EB74C4057}" type="datetimeFigureOut">
              <a:rPr lang="sv-SE" smtClean="0"/>
              <a:t>2017-09-13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0F0D-51FB-4F17-B731-F722AAE06AF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19328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258C-40E7-44D5-83D9-DC4EB74C4057}" type="datetimeFigureOut">
              <a:rPr lang="sv-SE" smtClean="0"/>
              <a:t>2017-09-13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0F0D-51FB-4F17-B731-F722AAE06AF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54450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258C-40E7-44D5-83D9-DC4EB74C4057}" type="datetimeFigureOut">
              <a:rPr lang="sv-SE" smtClean="0"/>
              <a:t>2017-09-13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10F0D-51FB-4F17-B731-F722AAE06AF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23998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E8258C-40E7-44D5-83D9-DC4EB74C4057}" type="datetimeFigureOut">
              <a:rPr lang="sv-SE" smtClean="0"/>
              <a:t>2017-09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810F0D-51FB-4F17-B731-F722AAE06AF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65385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</a:t>
            </a:r>
            <a:r>
              <a:rPr lang="sv-SE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sv-SE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rophy of the posterior subiculum is associated with memory impairment, tau- and Aβ pathology in non-demented individuals</a:t>
            </a:r>
            <a:r>
              <a:rPr lang="sv-SE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sv-SE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sv-SE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lof Lindberg</a:t>
            </a:r>
            <a:r>
              <a:rPr lang="sv-SE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&amp;2</a:t>
            </a:r>
            <a:r>
              <a:rPr lang="sv-SE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ustav Mårtensson</a:t>
            </a:r>
            <a:r>
              <a:rPr lang="sv-SE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sv-SE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rik Stomrud</a:t>
            </a:r>
            <a:r>
              <a:rPr lang="sv-SE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sv-SE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ebastian Palmqvist</a:t>
            </a:r>
            <a:r>
              <a:rPr lang="sv-SE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sv-SE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ars-Olof Wahlund</a:t>
            </a:r>
            <a:r>
              <a:rPr lang="sv-SE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sv-SE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ric Westman</a:t>
            </a:r>
            <a:r>
              <a:rPr lang="sv-SE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sv-SE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Oskar Hansson</a:t>
            </a:r>
            <a:r>
              <a:rPr lang="sv-SE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sv-SE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sv-SE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sv-SE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 Author: Olof.lindberg@ki.se</a:t>
            </a:r>
            <a:r>
              <a:rPr lang="sv-SE" sz="2000" dirty="0"/>
              <a:t/>
            </a:r>
            <a:br>
              <a:rPr lang="sv-SE" sz="2000" dirty="0"/>
            </a:br>
            <a:endParaRPr lang="sv-SE" sz="2000" dirty="0"/>
          </a:p>
        </p:txBody>
      </p:sp>
    </p:spTree>
    <p:extLst>
      <p:ext uri="{BB962C8B-B14F-4D97-AF65-F5344CB8AC3E}">
        <p14:creationId xmlns:p14="http://schemas.microsoft.com/office/powerpoint/2010/main" val="3245896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Bildobjekt 2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5140" y="402795"/>
            <a:ext cx="5598544" cy="6127401"/>
          </a:xfrm>
          <a:prstGeom prst="rect">
            <a:avLst/>
          </a:prstGeom>
        </p:spPr>
      </p:pic>
      <p:sp>
        <p:nvSpPr>
          <p:cNvPr id="4" name="textruta 3"/>
          <p:cNvSpPr txBox="1"/>
          <p:nvPr/>
        </p:nvSpPr>
        <p:spPr>
          <a:xfrm>
            <a:off x="216814" y="583590"/>
            <a:ext cx="50798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sv-SE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</a:t>
            </a:r>
            <a:r>
              <a:rPr lang="sv-SE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sv-SE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β</a:t>
            </a:r>
            <a:r>
              <a:rPr lang="en-US" b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2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tau</a:t>
            </a:r>
            <a:r>
              <a:rPr lang="en-US" b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sv-S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ruta 4"/>
          <p:cNvSpPr txBox="1"/>
          <p:nvPr/>
        </p:nvSpPr>
        <p:spPr>
          <a:xfrm>
            <a:off x="190358" y="138467"/>
            <a:ext cx="5900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sv-S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sv-S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1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ktangel 5"/>
          <p:cNvSpPr/>
          <p:nvPr/>
        </p:nvSpPr>
        <p:spPr>
          <a:xfrm>
            <a:off x="216814" y="4826675"/>
            <a:ext cx="5466840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400" dirty="0">
                <a:latin typeface="Times New Roman" panose="02020603050405020304" pitchFamily="18" charset="0"/>
                <a:ea typeface="WenQuanYi Micro Hei"/>
                <a:cs typeface="Times New Roman" panose="02020603050405020304" pitchFamily="18" charset="0"/>
              </a:rPr>
              <a:t>The figure denotes the interaction CSF biomarkers</a:t>
            </a:r>
            <a:r>
              <a:rPr lang="en-US" sz="1400" baseline="-25000" dirty="0">
                <a:latin typeface="Times New Roman" panose="02020603050405020304" pitchFamily="18" charset="0"/>
                <a:ea typeface="WenQuanYi Micro Hei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ea typeface="WenQuanYi Micro Hei"/>
                <a:cs typeface="Times New Roman" panose="02020603050405020304" pitchFamily="18" charset="0"/>
              </a:rPr>
              <a:t>and location (above, posterior segments 2-4 and anterior segments 5-10, and below, segments 1-6 and 7-10). A, left subiculum, left graph, normal CSF Aβ</a:t>
            </a:r>
            <a:r>
              <a:rPr lang="en-US" sz="1400" baseline="-25000" dirty="0">
                <a:latin typeface="Times New Roman" panose="02020603050405020304" pitchFamily="18" charset="0"/>
                <a:ea typeface="WenQuanYi Micro Hei"/>
                <a:cs typeface="Times New Roman" panose="02020603050405020304" pitchFamily="18" charset="0"/>
              </a:rPr>
              <a:t>42</a:t>
            </a:r>
            <a:r>
              <a:rPr lang="en-US" sz="1400" dirty="0">
                <a:latin typeface="Times New Roman" panose="02020603050405020304" pitchFamily="18" charset="0"/>
                <a:ea typeface="WenQuanYi Micro Hei"/>
                <a:cs typeface="Times New Roman" panose="02020603050405020304" pitchFamily="18" charset="0"/>
              </a:rPr>
              <a:t>, right graph, low levels of CSF Aβ</a:t>
            </a:r>
            <a:r>
              <a:rPr lang="en-US" sz="1400" baseline="-25000" dirty="0">
                <a:latin typeface="Times New Roman" panose="02020603050405020304" pitchFamily="18" charset="0"/>
                <a:ea typeface="WenQuanYi Micro Hei"/>
                <a:cs typeface="Times New Roman" panose="02020603050405020304" pitchFamily="18" charset="0"/>
              </a:rPr>
              <a:t>42</a:t>
            </a:r>
            <a:r>
              <a:rPr lang="en-US" sz="1400" dirty="0">
                <a:latin typeface="Times New Roman" panose="02020603050405020304" pitchFamily="18" charset="0"/>
                <a:ea typeface="WenQuanYi Micro Hei"/>
                <a:cs typeface="Times New Roman" panose="02020603050405020304" pitchFamily="18" charset="0"/>
              </a:rPr>
              <a:t>, B, right subiculum, left graph normal CSF Aβ</a:t>
            </a:r>
            <a:r>
              <a:rPr lang="en-US" sz="1400" baseline="-25000" dirty="0">
                <a:latin typeface="Times New Roman" panose="02020603050405020304" pitchFamily="18" charset="0"/>
                <a:ea typeface="WenQuanYi Micro Hei"/>
                <a:cs typeface="Times New Roman" panose="02020603050405020304" pitchFamily="18" charset="0"/>
              </a:rPr>
              <a:t>42</a:t>
            </a:r>
            <a:r>
              <a:rPr lang="en-US" sz="1400" dirty="0">
                <a:latin typeface="Times New Roman" panose="02020603050405020304" pitchFamily="18" charset="0"/>
                <a:ea typeface="WenQuanYi Micro Hei"/>
                <a:cs typeface="Times New Roman" panose="02020603050405020304" pitchFamily="18" charset="0"/>
              </a:rPr>
              <a:t>, right graph, low CSF Aβ</a:t>
            </a:r>
            <a:r>
              <a:rPr lang="en-US" sz="1400" baseline="-25000" dirty="0">
                <a:latin typeface="Times New Roman" panose="02020603050405020304" pitchFamily="18" charset="0"/>
                <a:ea typeface="WenQuanYi Micro Hei"/>
                <a:cs typeface="Times New Roman" panose="02020603050405020304" pitchFamily="18" charset="0"/>
              </a:rPr>
              <a:t>42</a:t>
            </a:r>
            <a:r>
              <a:rPr lang="en-US" sz="1400" dirty="0">
                <a:latin typeface="Times New Roman" panose="02020603050405020304" pitchFamily="18" charset="0"/>
                <a:ea typeface="WenQuanYi Micro Hei"/>
                <a:cs typeface="Times New Roman" panose="02020603050405020304" pitchFamily="18" charset="0"/>
              </a:rPr>
              <a:t>, Graph A blue line, left posterior segments 2-4, red line, left segment 5-10, Graph B blue line, right posterior segments 1-6, red line, segments 7-10, X-axis, P-tau 0, normal CSF P-tau, P-tau 1, elevated P-tau.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rtical bars denote 95% confidence interval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Rubrik 1"/>
          <p:cNvSpPr txBox="1">
            <a:spLocks/>
          </p:cNvSpPr>
          <p:nvPr/>
        </p:nvSpPr>
        <p:spPr>
          <a:xfrm>
            <a:off x="216814" y="1104505"/>
            <a:ext cx="5779698" cy="1325563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sv-SE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sv-SE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sv-SE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1. </a:t>
            </a:r>
            <a:endParaRPr lang="en-US" sz="14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analysis in the paper suggests that particularly the posterior part of the hippocampal body may be sensitive to AD pathology. To further investigate this we used a factorial analysis of variance which included CSF Aβ</a:t>
            </a:r>
            <a:r>
              <a:rPr lang="en-US" sz="14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high vs. low) and CSF P-tau (high vs. low) levels as factors and the summarized volume of left segments 2-4 and 5-10 and right segments 1-6 and 7-10 as dependent variables. The dependent variables were normalized for intracranial volume by the formula volume of structure/intracranial volume. This analysis revealed a significant interaction effect in the left subiculum between CSF P-tau and Aβ</a:t>
            </a:r>
            <a:r>
              <a:rPr lang="en-US" sz="14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[F(2,650)=3.15, p=0.04] in the whole cohort, which revealed that only posterior segments 2-4 were affected by elevated CSF P-tau levels in participants with normal CSF Aβ</a:t>
            </a:r>
            <a:r>
              <a:rPr lang="en-US" sz="14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evels, while both segments 2-4 and 5-10 decreased in volume in participants with low CSF Aβ</a:t>
            </a:r>
            <a:r>
              <a:rPr lang="en-US" sz="14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evels and elevated CSF P-tau levels (figure 4A).  A similar pattern was seen on the right side. However, the interactions were not significant for segments 2-4 vs. 5-10 or 1-6 vs. 7-10 (figure 4B). Interestingly, if the cut-off value for P-tau was increased to 70 ng/l, both the anterior and posterior left segments decreased in volume in participants with normal Aβ</a:t>
            </a:r>
            <a:r>
              <a:rPr lang="en-US" sz="14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evels and elevated P-tau levels.</a:t>
            </a:r>
            <a:r>
              <a:rPr lang="sv-SE" sz="1400" dirty="0" smtClean="0"/>
              <a:t/>
            </a:r>
            <a:br>
              <a:rPr lang="sv-SE" sz="1400" dirty="0" smtClean="0"/>
            </a:br>
            <a:r>
              <a:rPr lang="en-US" sz="1400" dirty="0" smtClean="0"/>
              <a:t> </a:t>
            </a:r>
            <a:r>
              <a:rPr lang="sv-SE" sz="1400" dirty="0" smtClean="0"/>
              <a:t/>
            </a:r>
            <a:br>
              <a:rPr lang="sv-SE" sz="1400" dirty="0" smtClean="0"/>
            </a:br>
            <a:r>
              <a:rPr lang="en-US" sz="1400" dirty="0" smtClean="0"/>
              <a:t> </a:t>
            </a:r>
            <a:endParaRPr lang="sv-SE" sz="1400" dirty="0"/>
          </a:p>
        </p:txBody>
      </p:sp>
    </p:spTree>
    <p:extLst>
      <p:ext uri="{BB962C8B-B14F-4D97-AF65-F5344CB8AC3E}">
        <p14:creationId xmlns:p14="http://schemas.microsoft.com/office/powerpoint/2010/main" val="1645114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507819" y="836189"/>
            <a:ext cx="4000448" cy="1325563"/>
          </a:xfrm>
        </p:spPr>
        <p:txBody>
          <a:bodyPr>
            <a:no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D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normal CSF Aβ</a:t>
            </a:r>
            <a:r>
              <a:rPr lang="en-US" sz="14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-tau levels</a:t>
            </a:r>
            <a:r>
              <a:rPr lang="sv-SE" sz="1400" dirty="0" smtClean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sv-SE" sz="1400" dirty="0" smtClean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D subjects with normal CSF Aβ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P-tau levels displayed more atrophy in the posterior subiculum in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rison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CN with normal Aβ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P-tau, but no interaction effect (diagnosis vs. location along the anterior posterior axis) was significant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.  </a:t>
            </a:r>
            <a:r>
              <a:rPr lang="sv-SE" sz="1400" dirty="0"/>
              <a:t/>
            </a:r>
            <a:br>
              <a:rPr lang="sv-SE" sz="1400" dirty="0"/>
            </a:br>
            <a:endParaRPr lang="sv-SE" sz="1400" dirty="0"/>
          </a:p>
        </p:txBody>
      </p:sp>
      <p:pic>
        <p:nvPicPr>
          <p:cNvPr id="3" name="Bildobjekt 2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8295" y="285918"/>
            <a:ext cx="7014619" cy="5856090"/>
          </a:xfrm>
          <a:prstGeom prst="rect">
            <a:avLst/>
          </a:prstGeom>
        </p:spPr>
      </p:pic>
      <p:sp>
        <p:nvSpPr>
          <p:cNvPr id="4" name="textruta 3"/>
          <p:cNvSpPr txBox="1"/>
          <p:nvPr/>
        </p:nvSpPr>
        <p:spPr>
          <a:xfrm>
            <a:off x="507819" y="2406588"/>
            <a:ext cx="4000448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gure denotes differences in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icula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olume segment in SCD (red line) and CN (blue line) with normal levels of Aβ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-tau (Aβ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, left, B, right; P-tau, C, left, D, right).  The x-axis denotes volume segments from posterior (segment 1) to anterior (segment 10). The y-axis denotes the volume of segments normalized as z-scores. Analysis is controlled for gender, intracranial volume and age. Vertical bars denote 95% confidence interval.</a:t>
            </a:r>
            <a:endParaRPr lang="sv-S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b="1" dirty="0"/>
              <a:t> </a:t>
            </a:r>
            <a:endParaRPr lang="sv-SE" sz="1400" dirty="0"/>
          </a:p>
        </p:txBody>
      </p:sp>
      <p:sp>
        <p:nvSpPr>
          <p:cNvPr id="5" name="textruta 4"/>
          <p:cNvSpPr txBox="1"/>
          <p:nvPr/>
        </p:nvSpPr>
        <p:spPr>
          <a:xfrm>
            <a:off x="507819" y="222021"/>
            <a:ext cx="5900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sv-SE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sv-SE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2.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18318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508701" y="1281763"/>
            <a:ext cx="3916650" cy="2129295"/>
          </a:xfrm>
        </p:spPr>
        <p:txBody>
          <a:bodyPr>
            <a:no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CI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normal levels of Aβ42 or P-tau </a:t>
            </a:r>
            <a:r>
              <a:rPr lang="sv-SE" sz="1400" dirty="0" smtClean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sv-SE" sz="1400" dirty="0" smtClean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nalysis revealed a significant interaction between diagnosis CN and MCI patients with normal levels of Aβ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location in the left [F(9, 2385)=2.73, p&lt;0.01] and the right [F(9, 2340)=2.22, p=0.02]. </a:t>
            </a:r>
            <a:r>
              <a:rPr lang="sv-SE" sz="1800" dirty="0"/>
              <a:t/>
            </a:r>
            <a:br>
              <a:rPr lang="sv-SE" sz="1800" dirty="0"/>
            </a:br>
            <a:endParaRPr lang="sv-SE" sz="1800" dirty="0"/>
          </a:p>
        </p:txBody>
      </p:sp>
      <p:pic>
        <p:nvPicPr>
          <p:cNvPr id="3" name="Bildobjekt 2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5351" y="549528"/>
            <a:ext cx="7151298" cy="5471709"/>
          </a:xfrm>
          <a:prstGeom prst="rect">
            <a:avLst/>
          </a:prstGeom>
        </p:spPr>
      </p:pic>
      <p:sp>
        <p:nvSpPr>
          <p:cNvPr id="4" name="textruta 3"/>
          <p:cNvSpPr txBox="1"/>
          <p:nvPr/>
        </p:nvSpPr>
        <p:spPr>
          <a:xfrm>
            <a:off x="508701" y="730980"/>
            <a:ext cx="5900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 err="1" smtClean="0"/>
              <a:t>Supplementary</a:t>
            </a:r>
            <a:r>
              <a:rPr lang="sv-SE" b="1" dirty="0" smtClean="0"/>
              <a:t> </a:t>
            </a:r>
            <a:r>
              <a:rPr lang="sv-SE" b="1" dirty="0" err="1" smtClean="0"/>
              <a:t>figure</a:t>
            </a:r>
            <a:r>
              <a:rPr lang="sv-SE" b="1" dirty="0" smtClean="0"/>
              <a:t> S3.</a:t>
            </a:r>
            <a:endParaRPr lang="en-US" b="1" dirty="0"/>
          </a:p>
        </p:txBody>
      </p:sp>
      <p:sp>
        <p:nvSpPr>
          <p:cNvPr id="5" name="Rektangel 4"/>
          <p:cNvSpPr/>
          <p:nvPr/>
        </p:nvSpPr>
        <p:spPr>
          <a:xfrm>
            <a:off x="508701" y="3174139"/>
            <a:ext cx="3663609" cy="22467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gure denotes differences in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icula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olume segment in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CI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d line) and CN (blue line) with normal levels of Aβ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-tau (Aβ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, left, B, right; P-tau, C, left, D, right).  The x-axis denotes volume segments from posterior (segment 1) to anterior (segment 10). The y-axis denotes the volume of segments normalized as z-scores. Analysis is controlled for gender, intracranial volume and age. Vertical bars denote 95% confidence interval.</a:t>
            </a:r>
            <a:endParaRPr lang="sv-S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49562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633069" y="867866"/>
            <a:ext cx="10515600" cy="1325563"/>
          </a:xfrm>
        </p:spPr>
        <p:txBody>
          <a:bodyPr>
            <a:normAutofit/>
          </a:bodyPr>
          <a:lstStyle/>
          <a:p>
            <a:r>
              <a:rPr lang="en-US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N 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high CSF Aβ</a:t>
            </a:r>
            <a:r>
              <a:rPr lang="en-US" sz="18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ed with CN with low CSF Aβ</a:t>
            </a:r>
            <a:r>
              <a:rPr lang="en-US" sz="18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r>
              <a:rPr lang="sv-SE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sv-SE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sv-SE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Bildobjekt 2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7561" y="3444413"/>
            <a:ext cx="7665542" cy="2999520"/>
          </a:xfrm>
          <a:prstGeom prst="rect">
            <a:avLst/>
          </a:prstGeom>
        </p:spPr>
      </p:pic>
      <p:sp>
        <p:nvSpPr>
          <p:cNvPr id="4" name="Rektangel 3"/>
          <p:cNvSpPr/>
          <p:nvPr/>
        </p:nvSpPr>
        <p:spPr>
          <a:xfrm>
            <a:off x="550527" y="1899596"/>
            <a:ext cx="3245097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4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figure denotes the total volume of left [A, Current effect: F(1,283)=4,52, p=0.03] and right [B, Current effect: F(1,277)=1.19, p=0.28] subiculum in CN participants with low levels of </a:t>
            </a:r>
            <a:r>
              <a:rPr lang="en-US" sz="1400" dirty="0" smtClean="0">
                <a:effectLst/>
                <a:latin typeface="Times New Roman" panose="02020603050405020304" pitchFamily="18" charset="0"/>
                <a:ea typeface="WenQuanYi Micro Hei"/>
                <a:cs typeface="Times New Roman" panose="02020603050405020304" pitchFamily="18" charset="0"/>
              </a:rPr>
              <a:t>Aβ</a:t>
            </a:r>
            <a:r>
              <a:rPr lang="en-US" sz="1400" baseline="-25000" dirty="0" smtClean="0">
                <a:effectLst/>
                <a:latin typeface="Times New Roman" panose="02020603050405020304" pitchFamily="18" charset="0"/>
                <a:ea typeface="WenQuanYi Micro Hei"/>
                <a:cs typeface="Times New Roman" panose="02020603050405020304" pitchFamily="18" charset="0"/>
              </a:rPr>
              <a:t>42</a:t>
            </a:r>
            <a:r>
              <a:rPr lang="en-US" sz="1400" dirty="0" smtClean="0">
                <a:effectLst/>
                <a:latin typeface="Times New Roman" panose="02020603050405020304" pitchFamily="18" charset="0"/>
                <a:ea typeface="WenQuanYi Micro Hei"/>
                <a:cs typeface="Times New Roman" panose="02020603050405020304" pitchFamily="18" charset="0"/>
              </a:rPr>
              <a:t> (CN1) and normal levels of Aβ</a:t>
            </a:r>
            <a:r>
              <a:rPr lang="en-US" sz="1400" baseline="-25000" dirty="0" smtClean="0">
                <a:effectLst/>
                <a:latin typeface="Times New Roman" panose="02020603050405020304" pitchFamily="18" charset="0"/>
                <a:ea typeface="WenQuanYi Micro Hei"/>
                <a:cs typeface="Times New Roman" panose="02020603050405020304" pitchFamily="18" charset="0"/>
              </a:rPr>
              <a:t>42</a:t>
            </a:r>
            <a:r>
              <a:rPr lang="en-US" sz="1400" dirty="0" smtClean="0">
                <a:effectLst/>
                <a:latin typeface="Times New Roman" panose="02020603050405020304" pitchFamily="18" charset="0"/>
                <a:ea typeface="WenQuanYi Micro Hei"/>
                <a:cs typeface="Times New Roman" panose="02020603050405020304" pitchFamily="18" charset="0"/>
              </a:rPr>
              <a:t> (CN0).</a:t>
            </a:r>
            <a:endParaRPr lang="sv-SE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ruta 5"/>
          <p:cNvSpPr txBox="1"/>
          <p:nvPr/>
        </p:nvSpPr>
        <p:spPr>
          <a:xfrm>
            <a:off x="633069" y="374767"/>
            <a:ext cx="5900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sv-SE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sv-SE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4.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62850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657</Words>
  <Application>Microsoft Office PowerPoint</Application>
  <PresentationFormat>Bredbild</PresentationFormat>
  <Paragraphs>16</Paragraphs>
  <Slides>5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5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WenQuanYi Micro Hei</vt:lpstr>
      <vt:lpstr>Office-tema</vt:lpstr>
      <vt:lpstr>Supplementary Material Atrophy of the posterior subiculum is associated with memory impairment, tau- and Aβ pathology in non-demented individuals Olof Lindberg1&amp;2, Gustav Mårtensson1, Erik Stomrud2, Sebastian Palmqvist2, Lars-Olof Wahlund1, Eric Westman1, Oskar Hansson2  Corresponding Author: Olof.lindberg@ki.se </vt:lpstr>
      <vt:lpstr>PowerPoint-presentation</vt:lpstr>
      <vt:lpstr>SCD with normal CSF Aβ42 and P-tau levels SCD subjects with normal CSF Aβ42 or P-tau levels displayed more atrophy in the posterior subiculum in comprison to CN with normal Aβ42 or P-tau, but no interaction effect (diagnosis vs. location along the anterior posterior axis) was significant..   </vt:lpstr>
      <vt:lpstr>MCI patients with normal levels of Aβ42 or P-tau  The analysis revealed a significant interaction between diagnosis CN and MCI patients with normal levels of Aβ42 and location in the left [F(9, 2385)=2.73, p&lt;0.01] and the right [F(9, 2340)=2.22, p=0.02].  </vt:lpstr>
      <vt:lpstr>CN with high CSF Aβ42 compared with CN with low CSF Aβ42 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 Atrophy of the posterior subiculum is associated with memory impairment, tau- and Aβ pathology in non-demented individuals Olof Lindberg1&amp;2, Gustav Mårtensson1, Erik Stomrud2, Sebastian Palmqvist2, Lars-Olof Wahlund1, Eric Westman1, Oskar Hansson2  Corresponding Author: Olof.lindberg@ki.se</dc:title>
  <dc:creator>Olof Lindberg</dc:creator>
  <cp:lastModifiedBy>Olof Lindberg</cp:lastModifiedBy>
  <cp:revision>14</cp:revision>
  <dcterms:created xsi:type="dcterms:W3CDTF">2017-08-21T13:47:08Z</dcterms:created>
  <dcterms:modified xsi:type="dcterms:W3CDTF">2017-09-13T13:11:19Z</dcterms:modified>
</cp:coreProperties>
</file>